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14544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0F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68" autoAdjust="0"/>
    <p:restoredTop sz="94660"/>
  </p:normalViewPr>
  <p:slideViewPr>
    <p:cSldViewPr snapToGrid="0">
      <p:cViewPr>
        <p:scale>
          <a:sx n="50" d="100"/>
          <a:sy n="50" d="100"/>
        </p:scale>
        <p:origin x="144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80345"/>
            <a:ext cx="10363200" cy="506370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639322"/>
            <a:ext cx="9144000" cy="351159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0049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118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74369"/>
            <a:ext cx="2628900" cy="12325940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74369"/>
            <a:ext cx="7734300" cy="12325940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6832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411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626072"/>
            <a:ext cx="10515600" cy="605018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733489"/>
            <a:ext cx="10515600" cy="31816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88006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71846"/>
            <a:ext cx="5181600" cy="92284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71846"/>
            <a:ext cx="5181600" cy="92284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96505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74373"/>
            <a:ext cx="10515600" cy="2811298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65467"/>
            <a:ext cx="5157787" cy="174738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312847"/>
            <a:ext cx="5157787" cy="781439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65467"/>
            <a:ext cx="5183188" cy="174738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312847"/>
            <a:ext cx="5183188" cy="781439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9073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54778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7352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9645"/>
            <a:ext cx="3932237" cy="339375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94167"/>
            <a:ext cx="6172200" cy="1033614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63402"/>
            <a:ext cx="3932237" cy="808374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30598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9645"/>
            <a:ext cx="3932237" cy="339375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94167"/>
            <a:ext cx="6172200" cy="1033614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63402"/>
            <a:ext cx="3932237" cy="808374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6363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74373"/>
            <a:ext cx="10515600" cy="28112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71846"/>
            <a:ext cx="10515600" cy="92284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480762"/>
            <a:ext cx="27432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57B43-9614-4098-99A4-9CB7D798ABA5}" type="datetimeFigureOut">
              <a:rPr lang="zh-TW" altLang="en-US" smtClean="0"/>
              <a:t>2025/8/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480762"/>
            <a:ext cx="41148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480762"/>
            <a:ext cx="2743200" cy="774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B5EF1-A914-4868-89E6-81493A8E400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4722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內容版面配置區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51789995"/>
              </p:ext>
            </p:extLst>
          </p:nvPr>
        </p:nvGraphicFramePr>
        <p:xfrm>
          <a:off x="287868" y="1972924"/>
          <a:ext cx="11387664" cy="9540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65296">
                  <a:extLst>
                    <a:ext uri="{9D8B030D-6E8A-4147-A177-3AD203B41FA5}">
                      <a16:colId xmlns:a16="http://schemas.microsoft.com/office/drawing/2014/main" val="666004276"/>
                    </a:ext>
                  </a:extLst>
                </a:gridCol>
                <a:gridCol w="1265296">
                  <a:extLst>
                    <a:ext uri="{9D8B030D-6E8A-4147-A177-3AD203B41FA5}">
                      <a16:colId xmlns:a16="http://schemas.microsoft.com/office/drawing/2014/main" val="2314413362"/>
                    </a:ext>
                  </a:extLst>
                </a:gridCol>
                <a:gridCol w="1169340">
                  <a:extLst>
                    <a:ext uri="{9D8B030D-6E8A-4147-A177-3AD203B41FA5}">
                      <a16:colId xmlns:a16="http://schemas.microsoft.com/office/drawing/2014/main" val="2649519178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3734404722"/>
                    </a:ext>
                  </a:extLst>
                </a:gridCol>
                <a:gridCol w="1333500">
                  <a:extLst>
                    <a:ext uri="{9D8B030D-6E8A-4147-A177-3AD203B41FA5}">
                      <a16:colId xmlns:a16="http://schemas.microsoft.com/office/drawing/2014/main" val="2847404392"/>
                    </a:ext>
                  </a:extLst>
                </a:gridCol>
                <a:gridCol w="1339144">
                  <a:extLst>
                    <a:ext uri="{9D8B030D-6E8A-4147-A177-3AD203B41FA5}">
                      <a16:colId xmlns:a16="http://schemas.microsoft.com/office/drawing/2014/main" val="31286104"/>
                    </a:ext>
                  </a:extLst>
                </a:gridCol>
                <a:gridCol w="1095021">
                  <a:extLst>
                    <a:ext uri="{9D8B030D-6E8A-4147-A177-3AD203B41FA5}">
                      <a16:colId xmlns:a16="http://schemas.microsoft.com/office/drawing/2014/main" val="82559390"/>
                    </a:ext>
                  </a:extLst>
                </a:gridCol>
                <a:gridCol w="1435571">
                  <a:extLst>
                    <a:ext uri="{9D8B030D-6E8A-4147-A177-3AD203B41FA5}">
                      <a16:colId xmlns:a16="http://schemas.microsoft.com/office/drawing/2014/main" val="1939707594"/>
                    </a:ext>
                  </a:extLst>
                </a:gridCol>
                <a:gridCol w="1265296">
                  <a:extLst>
                    <a:ext uri="{9D8B030D-6E8A-4147-A177-3AD203B41FA5}">
                      <a16:colId xmlns:a16="http://schemas.microsoft.com/office/drawing/2014/main" val="546307184"/>
                    </a:ext>
                  </a:extLst>
                </a:gridCol>
              </a:tblGrid>
              <a:tr h="56623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Outcomes</a:t>
                      </a:r>
                    </a:p>
                    <a:p>
                      <a:pPr algn="ctr"/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Matching status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horts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Patients </a:t>
                      </a:r>
                    </a:p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in cohort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 Patients with outcome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Survival probability </a:t>
                      </a:r>
                    </a:p>
                    <a:p>
                      <a:pPr algn="ctr"/>
                      <a:r>
                        <a:rPr lang="en-US" altLang="zh-TW" sz="800" dirty="0">
                          <a:latin typeface="+mn-lt"/>
                        </a:rPr>
                        <a:t>at end of time window</a:t>
                      </a:r>
                      <a:endParaRPr lang="zh-TW" altLang="en-US" sz="8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200" dirty="0">
                          <a:latin typeface="+mn-lt"/>
                        </a:rPr>
                        <a:t>Hazard Ratio</a:t>
                      </a:r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95% CI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og-Rank test</a:t>
                      </a:r>
                    </a:p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 value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white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/>
                      <a:endParaRPr lang="zh-TW" altLang="en-US" sz="1200" dirty="0">
                        <a:latin typeface="+mn-lt"/>
                      </a:endParaRPr>
                    </a:p>
                  </a:txBody>
                  <a:tcPr>
                    <a:solidFill>
                      <a:srgbClr val="2A0F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604720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All-cause</a:t>
                      </a:r>
                      <a:r>
                        <a:rPr lang="en-US" altLang="zh-TW" sz="1800" b="1" baseline="0" dirty="0">
                          <a:latin typeface="+mn-lt"/>
                        </a:rPr>
                        <a:t> mortality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53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7.78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05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0.885, 1.268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52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6590787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6,53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86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7.91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827789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45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7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896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0.709, 1.131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35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5217048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,4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4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97.50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1514800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MACE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,10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,16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76.2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46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372, 1.556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4132055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9,84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6,01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83.2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450600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06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115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6.2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264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159, 1.378)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7677076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36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93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80.8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5405367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AKI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6,52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58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0.47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2.05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875, 2.255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9174119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47,142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,95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5.3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313996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45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7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0.57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659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449, 1.899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1138567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51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3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4.34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6821839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Pneumonia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6,36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426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2.93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61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456, 1.798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7189495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46,14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,80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5.61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923855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28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1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2.9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438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236, 1.673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750000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35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28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5.13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5199884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GFR &lt; 30 ml/min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6,37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12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89.90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327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217, 1.447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246401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46,035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3,16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2.24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9240093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29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0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89.92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356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Times New Roman" panose="02020603050405020304" pitchFamily="18" charset="0"/>
                        </a:rPr>
                        <a:t>(1.198, 1.534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2039170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36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431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2.5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1704872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1800" b="1" dirty="0">
                          <a:latin typeface="+mn-lt"/>
                        </a:rPr>
                        <a:t>GI bleeding</a:t>
                      </a:r>
                      <a:endParaRPr lang="zh-TW" altLang="en-US" sz="18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Before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6,28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38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0.92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762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603, 1.937)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86559441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45,643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2,10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4.85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686350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After</a:t>
                      </a:r>
                      <a:endParaRPr lang="zh-TW" alt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>
                          <a:latin typeface="+mn-lt"/>
                        </a:rPr>
                        <a:t>+ iron</a:t>
                      </a:r>
                      <a:endParaRPr lang="zh-TW" altLang="en-US" sz="1400" b="1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210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529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0.96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1.574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(1.371, 1.807)</a:t>
                      </a:r>
                      <a:endParaRPr lang="zh-TW" altLang="en-US" sz="1600" b="1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0.000</a:t>
                      </a:r>
                      <a:endParaRPr lang="zh-TW" altLang="en-US" sz="16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7648253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/>
                        <a:t>- ir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626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latin typeface="+mn-lt"/>
                        </a:rPr>
                        <a:t>324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94.28%</a:t>
                      </a:r>
                      <a:endParaRPr lang="zh-TW" altLang="en-US" sz="1600" b="1" dirty="0">
                        <a:latin typeface="+mn-lt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8190943"/>
                  </a:ext>
                </a:extLst>
              </a:tr>
            </a:tbl>
          </a:graphicData>
        </a:graphic>
      </p:graphicFrame>
      <p:sp>
        <p:nvSpPr>
          <p:cNvPr id="5" name="標題 1"/>
          <p:cNvSpPr>
            <a:spLocks noGrp="1"/>
          </p:cNvSpPr>
          <p:nvPr>
            <p:ph type="title"/>
          </p:nvPr>
        </p:nvSpPr>
        <p:spPr>
          <a:xfrm>
            <a:off x="287868" y="297370"/>
            <a:ext cx="11176000" cy="1510454"/>
          </a:xfrm>
        </p:spPr>
        <p:txBody>
          <a:bodyPr>
            <a:normAutofit/>
          </a:bodyPr>
          <a:lstStyle/>
          <a:p>
            <a:r>
              <a:rPr lang="en-US" altLang="zh-TW" sz="2000" b="1" dirty="0">
                <a:latin typeface="+mn-lt"/>
              </a:rPr>
              <a:t>Supplement </a:t>
            </a:r>
            <a:r>
              <a:rPr lang="en-US" altLang="zh-TW" sz="2000" b="1">
                <a:latin typeface="+mn-lt"/>
              </a:rPr>
              <a:t>Table S2</a:t>
            </a:r>
            <a:r>
              <a:rPr lang="en-US" altLang="zh-TW" sz="2000" b="1" dirty="0">
                <a:latin typeface="+mn-lt"/>
              </a:rPr>
              <a:t>. </a:t>
            </a:r>
            <a:r>
              <a:rPr lang="en-US" altLang="zh-TW" sz="2000" dirty="0">
                <a:latin typeface="+mn-lt"/>
              </a:rPr>
              <a:t>Five-year Kaplan–Meier survival curve analysis of outcomes in non-anemic female patients with stage 3 chronic kidney disease, comparing hazard ratios between (1) the unmatched cohort (before matching) and (2) the matched cohort (after matching) derived from the entire patient population.</a:t>
            </a:r>
            <a:endParaRPr lang="zh-TW" altLang="en-US" sz="20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222491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336</Words>
  <Application>Microsoft Office PowerPoint</Application>
  <PresentationFormat>Custom</PresentationFormat>
  <Paragraphs>1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upplement Table S2. Five-year Kaplan–Meier survival curve analysis of outcomes in non-anemic female patients with stage 3 chronic kidney disease, comparing hazard ratios between (1) the unmatched cohort (before matching) and (2) the matched cohort (after matching) derived from the entire patient population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Kuo-Cheng</dc:creator>
  <cp:lastModifiedBy>MDPI</cp:lastModifiedBy>
  <cp:revision>12</cp:revision>
  <dcterms:created xsi:type="dcterms:W3CDTF">2025-05-24T08:40:56Z</dcterms:created>
  <dcterms:modified xsi:type="dcterms:W3CDTF">2025-08-07T10:02:13Z</dcterms:modified>
</cp:coreProperties>
</file>